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5886FCBB-F41C-42F7-933B-7BDE3AE3053C}"/>
    <pc:docChg chg="undo custSel modSld">
      <pc:chgData name="OKAGAWA Tomohiro" userId="d74b3e309c52a267" providerId="LiveId" clId="{5886FCBB-F41C-42F7-933B-7BDE3AE3053C}" dt="2021-12-28T02:15:46.007" v="772" actId="1038"/>
      <pc:docMkLst>
        <pc:docMk/>
      </pc:docMkLst>
      <pc:sldChg chg="addSp modSp mod">
        <pc:chgData name="OKAGAWA Tomohiro" userId="d74b3e309c52a267" providerId="LiveId" clId="{5886FCBB-F41C-42F7-933B-7BDE3AE3053C}" dt="2021-12-28T02:15:46.007" v="772" actId="1038"/>
        <pc:sldMkLst>
          <pc:docMk/>
          <pc:sldMk cId="2879998273" sldId="256"/>
        </pc:sldMkLst>
        <pc:spChg chg="add mod">
          <ac:chgData name="OKAGAWA Tomohiro" userId="d74b3e309c52a267" providerId="LiveId" clId="{5886FCBB-F41C-42F7-933B-7BDE3AE3053C}" dt="2021-12-28T01:56:57.007" v="38" actId="1076"/>
          <ac:spMkLst>
            <pc:docMk/>
            <pc:sldMk cId="2879998273" sldId="256"/>
            <ac:spMk id="3" creationId="{3C71BA40-4C5F-4E3E-9FDF-10D59AB43C66}"/>
          </ac:spMkLst>
        </pc:spChg>
        <pc:graphicFrameChg chg="mod modGraphic">
          <ac:chgData name="OKAGAWA Tomohiro" userId="d74b3e309c52a267" providerId="LiveId" clId="{5886FCBB-F41C-42F7-933B-7BDE3AE3053C}" dt="2021-12-28T02:15:46.007" v="772" actId="1038"/>
          <ac:graphicFrameMkLst>
            <pc:docMk/>
            <pc:sldMk cId="2879998273" sldId="256"/>
            <ac:graphicFrameMk id="5" creationId="{28AA4524-C1F8-4974-A5E6-93C4C8CE70A8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9.635" v="763" actId="12788"/>
        <pc:sldMkLst>
          <pc:docMk/>
          <pc:sldMk cId="2176500321" sldId="257"/>
        </pc:sldMkLst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8" creationId="{CECC3651-6356-42BA-90D4-D53D8AF637D3}"/>
          </ac:spMkLst>
        </pc:spChg>
        <pc:spChg chg="mod">
          <ac:chgData name="OKAGAWA Tomohiro" userId="d74b3e309c52a267" providerId="LiveId" clId="{5886FCBB-F41C-42F7-933B-7BDE3AE3053C}" dt="2021-12-28T01:59:28.193" v="107" actId="14100"/>
          <ac:spMkLst>
            <pc:docMk/>
            <pc:sldMk cId="2176500321" sldId="257"/>
            <ac:spMk id="9" creationId="{847F998F-4C07-4B5A-A9F3-01507E6D6A75}"/>
          </ac:spMkLst>
        </pc:spChg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10" creationId="{FDE252EE-D3A8-4DB5-8025-9A869134AB24}"/>
          </ac:spMkLst>
        </pc:spChg>
        <pc:spChg chg="mod">
          <ac:chgData name="OKAGAWA Tomohiro" userId="d74b3e309c52a267" providerId="LiveId" clId="{5886FCBB-F41C-42F7-933B-7BDE3AE3053C}" dt="2021-12-28T01:59:24.992" v="106" actId="552"/>
          <ac:spMkLst>
            <pc:docMk/>
            <pc:sldMk cId="2176500321" sldId="257"/>
            <ac:spMk id="11" creationId="{182492F5-D548-4006-A7D9-7D539CD3BF35}"/>
          </ac:spMkLst>
        </pc:spChg>
        <pc:spChg chg="add mod">
          <ac:chgData name="OKAGAWA Tomohiro" userId="d74b3e309c52a267" providerId="LiveId" clId="{5886FCBB-F41C-42F7-933B-7BDE3AE3053C}" dt="2021-12-28T02:15:39.635" v="763" actId="12788"/>
          <ac:spMkLst>
            <pc:docMk/>
            <pc:sldMk cId="2176500321" sldId="257"/>
            <ac:spMk id="12" creationId="{388C4F0B-C68F-487B-8066-CF13BA86AD47}"/>
          </ac:spMkLst>
        </pc:spChg>
      </pc:sldChg>
      <pc:sldChg chg="addSp modSp mod">
        <pc:chgData name="OKAGAWA Tomohiro" userId="d74b3e309c52a267" providerId="LiveId" clId="{5886FCBB-F41C-42F7-933B-7BDE3AE3053C}" dt="2021-12-28T02:15:34.905" v="762" actId="12788"/>
        <pc:sldMkLst>
          <pc:docMk/>
          <pc:sldMk cId="3092454316" sldId="258"/>
        </pc:sldMkLst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5" creationId="{AD53BC56-9CD9-4537-BC22-509DD5F5CF28}"/>
          </ac:spMkLst>
        </pc:spChg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7" creationId="{06A4BC64-B92B-46C5-B952-67D03CDA8590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9" creationId="{FC20F88B-779B-4B8E-9592-36D12D5934CB}"/>
          </ac:spMkLst>
        </pc:spChg>
        <pc:spChg chg="add mod">
          <ac:chgData name="OKAGAWA Tomohiro" userId="d74b3e309c52a267" providerId="LiveId" clId="{5886FCBB-F41C-42F7-933B-7BDE3AE3053C}" dt="2021-12-28T02:15:34.905" v="762" actId="12788"/>
          <ac:spMkLst>
            <pc:docMk/>
            <pc:sldMk cId="3092454316" sldId="258"/>
            <ac:spMk id="12" creationId="{03367787-1E0C-454E-9F9C-AD79F92BB878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3" creationId="{04C3066E-2124-4B3A-A634-79A06F62DFAE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5" creationId="{B5C586AD-A457-4A2F-B5AB-05587D506C9B}"/>
          </ac:spMkLst>
        </pc:sp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4" creationId="{51D5F3E7-2D88-4977-9F1F-E68466E5775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6" creationId="{8D9A3B75-ED18-42AC-BA85-8E4D135AE78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0" creationId="{2F66BED3-B3FF-4B8B-ADB5-60003887B286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1" creationId="{DF1EE0C2-391D-4AF4-848F-B89D1098CCD9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4" creationId="{633FAB34-FE47-4EF9-B7B0-908C0DEE818E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0.670" v="761" actId="12788"/>
        <pc:sldMkLst>
          <pc:docMk/>
          <pc:sldMk cId="4162683584" sldId="259"/>
        </pc:sldMkLst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0" creationId="{FDE252EE-D3A8-4DB5-8025-9A869134AB24}"/>
          </ac:spMkLst>
        </pc:spChg>
        <pc:spChg chg="add mod">
          <ac:chgData name="OKAGAWA Tomohiro" userId="d74b3e309c52a267" providerId="LiveId" clId="{5886FCBB-F41C-42F7-933B-7BDE3AE3053C}" dt="2021-12-28T02:15:30.670" v="761" actId="12788"/>
          <ac:spMkLst>
            <pc:docMk/>
            <pc:sldMk cId="4162683584" sldId="259"/>
            <ac:spMk id="11" creationId="{110936BD-A3DB-4F7C-AF31-3592F0EA6EB6}"/>
          </ac:spMkLst>
        </pc:spChg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5" creationId="{917B32FB-9B87-4C4D-AA9B-FFC3E39069A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6" creationId="{AD5C1B79-42DB-4284-B402-5406663A737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7" creationId="{D41489B0-161B-4390-B14D-AF376C68EF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83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15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27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917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7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97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272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51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75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611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411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081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28AA4524-C1F8-4974-A5E6-93C4C8CE70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8924595"/>
              </p:ext>
            </p:extLst>
          </p:nvPr>
        </p:nvGraphicFramePr>
        <p:xfrm>
          <a:off x="792992" y="985044"/>
          <a:ext cx="3810000" cy="1384300"/>
        </p:xfrm>
        <a:graphic>
          <a:graphicData uri="http://schemas.openxmlformats.org/drawingml/2006/table">
            <a:tbl>
              <a:tblPr/>
              <a:tblGrid>
                <a:gridCol w="1257300">
                  <a:extLst>
                    <a:ext uri="{9D8B030D-6E8A-4147-A177-3AD203B41FA5}">
                      <a16:colId xmlns:a16="http://schemas.microsoft.com/office/drawing/2014/main" val="961937158"/>
                    </a:ext>
                  </a:extLst>
                </a:gridCol>
                <a:gridCol w="2552700">
                  <a:extLst>
                    <a:ext uri="{9D8B030D-6E8A-4147-A177-3AD203B41FA5}">
                      <a16:colId xmlns:a16="http://schemas.microsoft.com/office/drawing/2014/main" val="599918556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umbers of cattle with bovine leukosis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492474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−60~Day−31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02900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−30~Day−1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452326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0~Day30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332724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31~Day60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54104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thers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72000" marR="7200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8566910"/>
                  </a:ext>
                </a:extLst>
              </a:tr>
            </a:tbl>
          </a:graphicData>
        </a:graphic>
      </p:graphicFrame>
      <p:sp>
        <p:nvSpPr>
          <p:cNvPr id="3" name="TextBox 5">
            <a:extLst>
              <a:ext uri="{FF2B5EF4-FFF2-40B4-BE49-F238E27FC236}">
                <a16:creationId xmlns:a16="http://schemas.microsoft.com/office/drawing/2014/main" id="{3C71BA40-4C5F-4E3E-9FDF-10D59AB43C66}"/>
              </a:ext>
            </a:extLst>
          </p:cNvPr>
          <p:cNvSpPr txBox="1"/>
          <p:nvPr/>
        </p:nvSpPr>
        <p:spPr>
          <a:xfrm>
            <a:off x="671072" y="2540892"/>
            <a:ext cx="5452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cs typeface="Times New Roman" panose="02020603050405020304" pitchFamily="18" charset="0"/>
              </a:rPr>
              <a:t>Supplementary Table 1</a:t>
            </a:r>
            <a:endParaRPr lang="en-US" altLang="ja-JP" sz="12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The numbers of cattle diagnosed as bovine leukosis, related to Figure 1.</a:t>
            </a:r>
          </a:p>
        </p:txBody>
      </p:sp>
    </p:spTree>
    <p:extLst>
      <p:ext uri="{BB962C8B-B14F-4D97-AF65-F5344CB8AC3E}">
        <p14:creationId xmlns:p14="http://schemas.microsoft.com/office/powerpoint/2010/main" val="2879998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50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治木 大和</dc:creator>
  <cp:lastModifiedBy>Saranya Siva</cp:lastModifiedBy>
  <cp:revision>7</cp:revision>
  <dcterms:created xsi:type="dcterms:W3CDTF">2021-12-25T03:57:05Z</dcterms:created>
  <dcterms:modified xsi:type="dcterms:W3CDTF">2022-02-15T03:42:03Z</dcterms:modified>
</cp:coreProperties>
</file>